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5" r:id="rId2"/>
    <p:sldId id="282" r:id="rId3"/>
    <p:sldId id="290" r:id="rId4"/>
    <p:sldId id="291" r:id="rId5"/>
    <p:sldId id="281" r:id="rId6"/>
    <p:sldId id="293" r:id="rId7"/>
    <p:sldId id="295" r:id="rId8"/>
    <p:sldId id="296" r:id="rId9"/>
    <p:sldId id="297" r:id="rId10"/>
    <p:sldId id="278" r:id="rId11"/>
    <p:sldId id="294" r:id="rId12"/>
    <p:sldId id="283" r:id="rId1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168" autoAdjust="0"/>
    <p:restoredTop sz="94660"/>
  </p:normalViewPr>
  <p:slideViewPr>
    <p:cSldViewPr snapToGrid="0">
      <p:cViewPr>
        <p:scale>
          <a:sx n="75" d="100"/>
          <a:sy n="75" d="100"/>
        </p:scale>
        <p:origin x="2988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ooja Vaswani" userId="22baf0d2-7753-4a6a-8c2b-f698ff262cb1" providerId="ADAL" clId="{F7F3FB8E-5F7B-4221-96B0-8A21697D35E4}"/>
    <pc:docChg chg="modSld">
      <pc:chgData name="Pooja Vaswani" userId="22baf0d2-7753-4a6a-8c2b-f698ff262cb1" providerId="ADAL" clId="{F7F3FB8E-5F7B-4221-96B0-8A21697D35E4}" dt="2023-05-24T04:22:45.820" v="4" actId="207"/>
      <pc:docMkLst>
        <pc:docMk/>
      </pc:docMkLst>
      <pc:sldChg chg="modSp mod">
        <pc:chgData name="Pooja Vaswani" userId="22baf0d2-7753-4a6a-8c2b-f698ff262cb1" providerId="ADAL" clId="{F7F3FB8E-5F7B-4221-96B0-8A21697D35E4}" dt="2023-05-24T04:22:45.820" v="4" actId="207"/>
        <pc:sldMkLst>
          <pc:docMk/>
          <pc:sldMk cId="4210970355" sldId="281"/>
        </pc:sldMkLst>
        <pc:spChg chg="mod">
          <ac:chgData name="Pooja Vaswani" userId="22baf0d2-7753-4a6a-8c2b-f698ff262cb1" providerId="ADAL" clId="{F7F3FB8E-5F7B-4221-96B0-8A21697D35E4}" dt="2023-05-24T04:22:45.820" v="4" actId="207"/>
          <ac:spMkLst>
            <pc:docMk/>
            <pc:sldMk cId="4210970355" sldId="281"/>
            <ac:spMk id="2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0120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186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5905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058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54295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91293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6842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7792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6888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56642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3753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BC62A-7554-4B61-ACEF-01AB37C97FE6}" type="datetimeFigureOut">
              <a:rPr lang="ko-KR" altLang="en-US" smtClean="0"/>
              <a:t>2023-10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9DD6F-AB8A-44FF-84BD-ADF15E5B29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4115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0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7459" y="7384075"/>
            <a:ext cx="64807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Alignment between the generated model and the templates (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2GH8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GSI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Structural alignment between the two templates. (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equence identity and similarity of the generated model, aligned with the two templates. (C) Sequence alignment between the model and the two templates.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716" y="5405411"/>
            <a:ext cx="6494480" cy="1719263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827" y="1118771"/>
            <a:ext cx="4039105" cy="386680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844576" y="1261990"/>
            <a:ext cx="14078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: 2GH8</a:t>
            </a:r>
          </a:p>
          <a:p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: 6GSI</a:t>
            </a:r>
            <a:endParaRPr lang="ko-KR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0971644"/>
              </p:ext>
            </p:extLst>
          </p:nvPr>
        </p:nvGraphicFramePr>
        <p:xfrm>
          <a:off x="3899223" y="1788526"/>
          <a:ext cx="2582781" cy="72277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60927">
                  <a:extLst>
                    <a:ext uri="{9D8B030D-6E8A-4147-A177-3AD203B41FA5}">
                      <a16:colId xmlns:a16="http://schemas.microsoft.com/office/drawing/2014/main" val="828597688"/>
                    </a:ext>
                  </a:extLst>
                </a:gridCol>
                <a:gridCol w="860927">
                  <a:extLst>
                    <a:ext uri="{9D8B030D-6E8A-4147-A177-3AD203B41FA5}">
                      <a16:colId xmlns:a16="http://schemas.microsoft.com/office/drawing/2014/main" val="1869904032"/>
                    </a:ext>
                  </a:extLst>
                </a:gridCol>
                <a:gridCol w="860927">
                  <a:extLst>
                    <a:ext uri="{9D8B030D-6E8A-4147-A177-3AD203B41FA5}">
                      <a16:colId xmlns:a16="http://schemas.microsoft.com/office/drawing/2014/main" val="3988887486"/>
                    </a:ext>
                  </a:extLst>
                </a:gridCol>
              </a:tblGrid>
              <a:tr h="24092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GH8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GSI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5586027"/>
                  </a:ext>
                </a:extLst>
              </a:tr>
              <a:tr h="24092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GH8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2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49191306"/>
                  </a:ext>
                </a:extLst>
              </a:tr>
              <a:tr h="24092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GSI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11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600569"/>
                  </a:ext>
                </a:extLst>
              </a:tr>
            </a:tbl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102798" y="1215419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458836" y="1215419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02798" y="5056993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graphicFrame>
        <p:nvGraphicFramePr>
          <p:cNvPr id="13" name="표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136264"/>
              </p:ext>
            </p:extLst>
          </p:nvPr>
        </p:nvGraphicFramePr>
        <p:xfrm>
          <a:off x="3899223" y="2696946"/>
          <a:ext cx="2582781" cy="90857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60927">
                  <a:extLst>
                    <a:ext uri="{9D8B030D-6E8A-4147-A177-3AD203B41FA5}">
                      <a16:colId xmlns:a16="http://schemas.microsoft.com/office/drawing/2014/main" val="828597688"/>
                    </a:ext>
                  </a:extLst>
                </a:gridCol>
                <a:gridCol w="860927">
                  <a:extLst>
                    <a:ext uri="{9D8B030D-6E8A-4147-A177-3AD203B41FA5}">
                      <a16:colId xmlns:a16="http://schemas.microsoft.com/office/drawing/2014/main" val="1869904032"/>
                    </a:ext>
                  </a:extLst>
                </a:gridCol>
                <a:gridCol w="860927">
                  <a:extLst>
                    <a:ext uri="{9D8B030D-6E8A-4147-A177-3AD203B41FA5}">
                      <a16:colId xmlns:a16="http://schemas.microsoft.com/office/drawing/2014/main" val="3988887486"/>
                    </a:ext>
                  </a:extLst>
                </a:gridCol>
              </a:tblGrid>
              <a:tr h="24092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dentity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ilarity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5586027"/>
                  </a:ext>
                </a:extLst>
              </a:tr>
              <a:tr h="12046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GH8, 6GSI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3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.7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649191306"/>
                  </a:ext>
                </a:extLst>
              </a:tr>
              <a:tr h="120463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GH8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.4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3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42843886"/>
                  </a:ext>
                </a:extLst>
              </a:tr>
              <a:tr h="24092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GSI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.4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8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1%</a:t>
                      </a:r>
                      <a:endParaRPr lang="ko-KR" altLang="en-US" sz="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6005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69061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464" y="2471029"/>
            <a:ext cx="3219022" cy="306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07459" y="6546794"/>
            <a:ext cx="6480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0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vated structure of the walrus calicivirus capsid protein homology model complexes with (a) PH14 and (b) PH15.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68214" y="1893075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87774" y="1893075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/>
          <a:srcRect l="8524" r="2866"/>
          <a:stretch/>
        </p:blipFill>
        <p:spPr>
          <a:xfrm>
            <a:off x="3481810" y="2386808"/>
            <a:ext cx="3206369" cy="30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46369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직사각형 17"/>
          <p:cNvSpPr/>
          <p:nvPr/>
        </p:nvSpPr>
        <p:spPr>
          <a:xfrm>
            <a:off x="-3994" y="703308"/>
            <a:ext cx="6861994" cy="66409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187890" y="7905996"/>
            <a:ext cx="648072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1. Post-MD structure of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4-walrus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iciviru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psid protein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lex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4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shown as a gray/red stick model. The favorable hydrogen bond interaction of the post-MD complex is expressed as the (a) whole structure and (b) active site structure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625" y="2491873"/>
            <a:ext cx="2668569" cy="324040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1685" y="2451747"/>
            <a:ext cx="3464364" cy="3320657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88021" y="5126947"/>
            <a:ext cx="639003" cy="716596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17461" y="2574972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176294" y="2574972"/>
            <a:ext cx="231355" cy="27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2153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93397" y="7905996"/>
            <a:ext cx="64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2. Hydrogen bond interactions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PH14-walrus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icivirus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psid protein complex during MD simulation. 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025" y="525796"/>
            <a:ext cx="5695950" cy="7219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3120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4629" y="1280168"/>
            <a:ext cx="5736568" cy="51206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8476" y="7532904"/>
            <a:ext cx="64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Superimposed images of the generated homology model (blue) and the two templates (2GH8, red; 6GSI, green). 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176652" y="3194152"/>
            <a:ext cx="14078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: the model</a:t>
            </a: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: 2GH8</a:t>
            </a: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: 6GSI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69902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그림 2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6733" y="1531938"/>
            <a:ext cx="2520000" cy="252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450" y="4460029"/>
            <a:ext cx="3290121" cy="164506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4"/>
          <a:srcRect t="25682" b="25557"/>
          <a:stretch/>
        </p:blipFill>
        <p:spPr>
          <a:xfrm>
            <a:off x="360756" y="1935449"/>
            <a:ext cx="3672358" cy="99268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5"/>
          <a:srcRect t="23470" b="25300"/>
          <a:stretch/>
        </p:blipFill>
        <p:spPr>
          <a:xfrm>
            <a:off x="382096" y="2988823"/>
            <a:ext cx="3296312" cy="1024625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207459" y="6735600"/>
            <a:ext cx="648072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the homology model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quality of the homology model evaluated by the ERRAT program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n the error axis, two lines are drawn to indicate the confidence with which it is possible to reject regions that exceed that error value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75.14% of the amino acids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homology model hav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3D-1D score ≥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. (c) Z-scor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ighlighted as a black dot) is displayed in a plot that contains the Z-scores of all experimentally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hains currently available in th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Data Bank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roups of structures from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ces (X-ray and NMR) are distinguished by different colors (light and dark blue, respectively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d) Plot of single residue energy, where window size of 40 residues is distinguished by green line. Positive values indicate problematic or erroneous parts of the structure.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15719" y="1751651"/>
            <a:ext cx="22925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quality factor: 77.230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318315" y="3466950"/>
            <a:ext cx="18348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-score: -6.4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1" name="그림 2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6732" y="3964297"/>
            <a:ext cx="2520000" cy="25200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268214" y="1646338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68214" y="4121157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894120" y="1646338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94120" y="4121157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4105" y="5981979"/>
            <a:ext cx="3475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.14% of the amino acids have average 3D-1D score ≥ 0.1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438644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그림 3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745" y="3026819"/>
            <a:ext cx="2912604" cy="970868"/>
          </a:xfrm>
          <a:prstGeom prst="rect">
            <a:avLst/>
          </a:prstGeom>
        </p:spPr>
      </p:pic>
      <p:pic>
        <p:nvPicPr>
          <p:cNvPr id="27" name="그림 2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200" y="1533600"/>
            <a:ext cx="2520000" cy="2520000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7200" y="3964297"/>
            <a:ext cx="2520000" cy="252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07459" y="6735423"/>
            <a:ext cx="648072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Validation of Feline </a:t>
            </a:r>
            <a:r>
              <a:rPr lang="en-US" altLang="ko-KR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icivirus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psid protein (PDB ID: 3M8L)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quality of the homology model evaluated by the ERRAT program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On the error axis, two lines are drawn to indicate the confidence with which it is possible to reject regions that exceed that error value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67.98% of the amino acids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FCV capsid protein hav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3D-1D score ≥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. (c) Z-scor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highlighted as a black dot) is displayed in a plot that contains the Z-scores of all experimentally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rmined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hains currently available in th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Data Bank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roups of structures from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urces (X-ray and NMR) are distinguished by different colors (light and dark blue, respectively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d) Plot of single residue energy, where window size of 40 residues is distinguished by green line. Positive values indicate problematic or erroneous parts of the structure.</a:t>
            </a:r>
            <a:endParaRPr lang="en-US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15719" y="1751651"/>
            <a:ext cx="22925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all quality factor: 61.165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318315" y="3466950"/>
            <a:ext cx="18348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-score: -6.6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68214" y="1646338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68214" y="4121157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894120" y="1646338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894120" y="4121157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9" name="그림 3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0045" y="1935449"/>
            <a:ext cx="3530465" cy="962496"/>
          </a:xfrm>
          <a:prstGeom prst="rect">
            <a:avLst/>
          </a:prstGeom>
        </p:spPr>
      </p:pic>
      <p:pic>
        <p:nvPicPr>
          <p:cNvPr id="42" name="그림 4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901" y="4462608"/>
            <a:ext cx="3287670" cy="1643835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524105" y="5981979"/>
            <a:ext cx="3475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7.98%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amino acids have average 3D-1D score ≥ 0.1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61193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7459" y="8152173"/>
            <a:ext cx="64807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lored binding site spheres of the walrus calicivirus capsid protein homology model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Th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heres indicate the identified candidate binding sites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 The binding site of the outer VP1 surface which is the region of interaction with </a:t>
            </a:r>
            <a:r>
              <a:rPr lang="en-US" altLang="ko-KR" sz="14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JAM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 in the structure of FCV bound to </a:t>
            </a:r>
            <a:r>
              <a:rPr lang="en-US" altLang="ko-KR" sz="1400" dirty="0" err="1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JAM</a:t>
            </a:r>
            <a:r>
              <a:rPr lang="en-US" altLang="ko-KR" sz="14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A.</a:t>
            </a:r>
            <a:endParaRPr lang="en-US" altLang="ko-KR" sz="14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6618" y="808700"/>
            <a:ext cx="3963491" cy="313373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1992" y="4168079"/>
            <a:ext cx="3838342" cy="392780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0708" y="808700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03088" y="4192760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1428519" y="5388754"/>
            <a:ext cx="1371831" cy="683532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4692440" y="5861066"/>
            <a:ext cx="14078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: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P1 of FCV</a:t>
            </a:r>
            <a:endParaRPr lang="en-US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: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JAM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</a:t>
            </a:r>
          </a:p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ink: VP1 of FCV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09703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직사각형 14"/>
          <p:cNvSpPr/>
          <p:nvPr/>
        </p:nvSpPr>
        <p:spPr>
          <a:xfrm>
            <a:off x="0" y="275422"/>
            <a:ext cx="6699196" cy="74914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476" y="472186"/>
            <a:ext cx="4469638" cy="3798313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5768" y="810605"/>
            <a:ext cx="3744691" cy="312147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8648" y="472186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598290" y="472186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07459" y="7917557"/>
            <a:ext cx="648072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Predicted docking conformation of the PH14–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5–walrus </a:t>
            </a:r>
            <a:r>
              <a:rPr lang="en-US" altLang="ko-KR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licivirus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apsid protein complex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vorable hydrogen bond interaction of th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4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sid protein complex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expressed as the (a) whole structure and (b) active site structure. The favorable hydrogen bond interaction of th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5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psid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omplex is expressed as the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ole structure and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e site structure. </a:t>
            </a: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4"/>
          <a:srcRect b="2430"/>
          <a:stretch/>
        </p:blipFill>
        <p:spPr>
          <a:xfrm>
            <a:off x="236810" y="4213333"/>
            <a:ext cx="4652848" cy="3764807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47921" y="4541185"/>
            <a:ext cx="4049083" cy="3206670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231028" y="4199146"/>
            <a:ext cx="2313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590670" y="4199146"/>
            <a:ext cx="210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5688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576" y="5298468"/>
            <a:ext cx="6169226" cy="3017519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4322" y="516398"/>
            <a:ext cx="4201734" cy="4941727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2206171" y="1669143"/>
            <a:ext cx="3048000" cy="116114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293397" y="8315987"/>
            <a:ext cx="64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7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of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line junctional adhesion molecule A-FCV capsid protein complex (PDB ID: 6GSI)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268908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8462" y="589070"/>
            <a:ext cx="4493453" cy="4796382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535" y="5257776"/>
            <a:ext cx="5650444" cy="3159811"/>
          </a:xfrm>
          <a:prstGeom prst="rect">
            <a:avLst/>
          </a:prstGeom>
        </p:spPr>
      </p:pic>
      <p:sp>
        <p:nvSpPr>
          <p:cNvPr id="8" name="직사각형 7"/>
          <p:cNvSpPr/>
          <p:nvPr/>
        </p:nvSpPr>
        <p:spPr>
          <a:xfrm>
            <a:off x="1812632" y="1669143"/>
            <a:ext cx="3048000" cy="116114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직사각형 12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293397" y="8417587"/>
            <a:ext cx="64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8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of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line junctional adhesion molecule A-the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14–capsid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tein complex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43788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2"/>
          <a:srcRect b="5461"/>
          <a:stretch/>
        </p:blipFill>
        <p:spPr>
          <a:xfrm>
            <a:off x="1064264" y="589070"/>
            <a:ext cx="4544735" cy="4534473"/>
          </a:xfrm>
          <a:prstGeom prst="rect">
            <a:avLst/>
          </a:prstGeom>
        </p:spPr>
      </p:pic>
      <p:sp>
        <p:nvSpPr>
          <p:cNvPr id="8" name="직사각형 7"/>
          <p:cNvSpPr/>
          <p:nvPr/>
        </p:nvSpPr>
        <p:spPr>
          <a:xfrm>
            <a:off x="1812632" y="1669143"/>
            <a:ext cx="3048000" cy="1161143"/>
          </a:xfrm>
          <a:prstGeom prst="rect">
            <a:avLst/>
          </a:prstGeom>
          <a:noFill/>
          <a:ln>
            <a:solidFill>
              <a:schemeClr val="tx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직사각형 11"/>
          <p:cNvSpPr/>
          <p:nvPr/>
        </p:nvSpPr>
        <p:spPr>
          <a:xfrm>
            <a:off x="0" y="0"/>
            <a:ext cx="2845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b="1" kern="0" dirty="0">
                <a:latin typeface="Palatino Linotype" panose="02040502050505030304" pitchFamily="18" charset="0"/>
                <a:ea typeface="돋움" panose="020B0600000101010101" pitchFamily="50" charset="-127"/>
                <a:cs typeface="Times New Roman" panose="02020603050405020304" pitchFamily="18" charset="0"/>
              </a:rPr>
              <a:t>Supplementary materials</a:t>
            </a:r>
            <a:endParaRPr lang="ko-KR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93397" y="8417587"/>
            <a:ext cx="64807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9.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actions of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line junctional adhesion molecule A-the PH15–capsid protein complex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641" y="4993568"/>
            <a:ext cx="5974185" cy="34522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365031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0</TotalTime>
  <Words>831</Words>
  <Application>Microsoft Office PowerPoint</Application>
  <PresentationFormat>화면 슬라이드 쇼(4:3)</PresentationFormat>
  <Paragraphs>79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20" baseType="lpstr">
      <vt:lpstr>돋움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Foryoucom</dc:creator>
  <cp:lastModifiedBy>Foryoucom</cp:lastModifiedBy>
  <cp:revision>125</cp:revision>
  <dcterms:created xsi:type="dcterms:W3CDTF">2022-12-28T01:06:59Z</dcterms:created>
  <dcterms:modified xsi:type="dcterms:W3CDTF">2023-10-26T02:10:13Z</dcterms:modified>
</cp:coreProperties>
</file>